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  <p:sldId id="264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90" userDrawn="1">
          <p15:clr>
            <a:srgbClr val="A4A3A4"/>
          </p15:clr>
        </p15:guide>
        <p15:guide id="2" pos="32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6349" autoAdjust="0"/>
  </p:normalViewPr>
  <p:slideViewPr>
    <p:cSldViewPr snapToGrid="0" showGuides="1">
      <p:cViewPr varScale="1">
        <p:scale>
          <a:sx n="73" d="100"/>
          <a:sy n="73" d="100"/>
        </p:scale>
        <p:origin x="696" y="78"/>
      </p:cViewPr>
      <p:guideLst>
        <p:guide orient="horz" pos="3090"/>
        <p:guide pos="32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4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1F90-4FED-4751-8CF5-A9D19CEDEABF}" type="datetimeFigureOut">
              <a:rPr lang="de-DE" smtClean="0"/>
              <a:t>01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69FE0-4B1E-4DF4-B0CE-C5194E872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93786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1F90-4FED-4751-8CF5-A9D19CEDEABF}" type="datetimeFigureOut">
              <a:rPr lang="de-DE" smtClean="0"/>
              <a:t>01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69FE0-4B1E-4DF4-B0CE-C5194E872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404077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1F90-4FED-4751-8CF5-A9D19CEDEABF}" type="datetimeFigureOut">
              <a:rPr lang="de-DE" smtClean="0"/>
              <a:t>01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69FE0-4B1E-4DF4-B0CE-C5194E872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698162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1F90-4FED-4751-8CF5-A9D19CEDEABF}" type="datetimeFigureOut">
              <a:rPr lang="de-DE" smtClean="0"/>
              <a:t>01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69FE0-4B1E-4DF4-B0CE-C5194E872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00540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1F90-4FED-4751-8CF5-A9D19CEDEABF}" type="datetimeFigureOut">
              <a:rPr lang="de-DE" smtClean="0"/>
              <a:t>01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69FE0-4B1E-4DF4-B0CE-C5194E872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59779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1F90-4FED-4751-8CF5-A9D19CEDEABF}" type="datetimeFigureOut">
              <a:rPr lang="de-DE" smtClean="0"/>
              <a:t>01.06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69FE0-4B1E-4DF4-B0CE-C5194E872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740657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1F90-4FED-4751-8CF5-A9D19CEDEABF}" type="datetimeFigureOut">
              <a:rPr lang="de-DE" smtClean="0"/>
              <a:t>01.06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69FE0-4B1E-4DF4-B0CE-C5194E872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80304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1F90-4FED-4751-8CF5-A9D19CEDEABF}" type="datetimeFigureOut">
              <a:rPr lang="de-DE" smtClean="0"/>
              <a:t>01.06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69FE0-4B1E-4DF4-B0CE-C5194E872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3079615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1F90-4FED-4751-8CF5-A9D19CEDEABF}" type="datetimeFigureOut">
              <a:rPr lang="de-DE" smtClean="0"/>
              <a:t>01.06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69FE0-4B1E-4DF4-B0CE-C5194E872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301463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1F90-4FED-4751-8CF5-A9D19CEDEABF}" type="datetimeFigureOut">
              <a:rPr lang="de-DE" smtClean="0"/>
              <a:t>01.06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69FE0-4B1E-4DF4-B0CE-C5194E872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909798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2E1F90-4FED-4751-8CF5-A9D19CEDEABF}" type="datetimeFigureOut">
              <a:rPr lang="de-DE" smtClean="0"/>
              <a:t>01.06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269FE0-4B1E-4DF4-B0CE-C5194E872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715472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de-DE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de-DE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E1F90-4FED-4751-8CF5-A9D19CEDEABF}" type="datetimeFigureOut">
              <a:rPr lang="de-DE" smtClean="0"/>
              <a:t>01.06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269FE0-4B1E-4DF4-B0CE-C5194E87232A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36861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4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215483" y="358904"/>
            <a:ext cx="13248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.Fig.1</a:t>
            </a:r>
            <a:endParaRPr lang="en-US" sz="14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7F034-2B04-4A93-B668-DB09A8BFB54D}" type="slidenum">
              <a:rPr lang="en-US" smtClean="0"/>
              <a:t>1</a:t>
            </a:fld>
            <a:endParaRPr lang="en-US"/>
          </a:p>
        </p:txBody>
      </p:sp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3034586"/>
              </p:ext>
            </p:extLst>
          </p:nvPr>
        </p:nvGraphicFramePr>
        <p:xfrm>
          <a:off x="315277" y="1188819"/>
          <a:ext cx="3966431" cy="229514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39" name="Prism 8" r:id="rId3" imgW="4652953" imgH="2692512" progId="Prism8.Document">
                  <p:embed/>
                </p:oleObj>
              </mc:Choice>
              <mc:Fallback>
                <p:oleObj name="Prism 8" r:id="rId3" imgW="4652953" imgH="269251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15277" y="1188819"/>
                        <a:ext cx="3966431" cy="229514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2437829"/>
              </p:ext>
            </p:extLst>
          </p:nvPr>
        </p:nvGraphicFramePr>
        <p:xfrm>
          <a:off x="4281707" y="914400"/>
          <a:ext cx="4037111" cy="2569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40" name="Prism 8" r:id="rId5" imgW="4733984" imgH="3012689" progId="Prism8.Document">
                  <p:embed/>
                </p:oleObj>
              </mc:Choice>
              <mc:Fallback>
                <p:oleObj name="Prism 8" r:id="rId5" imgW="4733984" imgH="301268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281707" y="914400"/>
                        <a:ext cx="4037111" cy="2569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64623487"/>
              </p:ext>
            </p:extLst>
          </p:nvPr>
        </p:nvGraphicFramePr>
        <p:xfrm>
          <a:off x="8261199" y="1229493"/>
          <a:ext cx="3930802" cy="225446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241" name="Prism 8" r:id="rId7" imgW="4727862" imgH="2710879" progId="Prism8.Document">
                  <p:embed/>
                </p:oleObj>
              </mc:Choice>
              <mc:Fallback>
                <p:oleObj name="Prism 8" r:id="rId7" imgW="4727862" imgH="2710879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261199" y="1229493"/>
                        <a:ext cx="3930802" cy="225446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hteck 2"/>
          <p:cNvSpPr/>
          <p:nvPr/>
        </p:nvSpPr>
        <p:spPr>
          <a:xfrm>
            <a:off x="1854536" y="4546507"/>
            <a:ext cx="8891451" cy="199240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Suppl.Fig.1: Evaluation of  the neutralizing ability by antibodies of COVID-19 patients. 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</a:rPr>
              <a:t>Neutralization plaque assays were performed by 1h incubation of SARS-CoV-2 strains and 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a 1:10 to 1:2500 dilution range using only IgG positive plasma samples of COVID-19 patients. Neutralization curves were calculated using four-parameter nonlinear regression and percentages of neutralization is illustrated for mild (left), severe (middle) and severe (right) COVID-19. In addition, antibody categories are shown in brackets next to patient IDs. </a:t>
            </a:r>
            <a:endParaRPr lang="en-US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756252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E7F034-2B04-4A93-B668-DB09A8BFB54D}" type="slidenum">
              <a:rPr lang="en-US" smtClean="0"/>
              <a:t>2</a:t>
            </a:fld>
            <a:endParaRPr lang="en-US"/>
          </a:p>
        </p:txBody>
      </p:sp>
      <p:graphicFrame>
        <p:nvGraphicFramePr>
          <p:cNvPr id="3" name="Objet 2">
            <a:extLst>
              <a:ext uri="{FF2B5EF4-FFF2-40B4-BE49-F238E27FC236}">
                <a16:creationId xmlns:a16="http://schemas.microsoft.com/office/drawing/2014/main" id="{D71CB172-303B-4B96-AA6D-B0296CB3A54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5738988"/>
              </p:ext>
            </p:extLst>
          </p:nvPr>
        </p:nvGraphicFramePr>
        <p:xfrm>
          <a:off x="1036638" y="1185863"/>
          <a:ext cx="3521075" cy="3011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99" name="Prism 8" r:id="rId3" imgW="3155869" imgH="2698634" progId="Prism8.Document">
                  <p:embed/>
                </p:oleObj>
              </mc:Choice>
              <mc:Fallback>
                <p:oleObj name="Prism 8" r:id="rId3" imgW="3155869" imgH="269863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036638" y="1185863"/>
                        <a:ext cx="3521075" cy="30114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feld 6"/>
          <p:cNvSpPr txBox="1"/>
          <p:nvPr/>
        </p:nvSpPr>
        <p:spPr>
          <a:xfrm>
            <a:off x="883139" y="358904"/>
            <a:ext cx="13248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4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.Fig.2</a:t>
            </a:r>
            <a:endParaRPr lang="en-US" sz="14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hteck 3"/>
          <p:cNvSpPr/>
          <p:nvPr/>
        </p:nvSpPr>
        <p:spPr>
          <a:xfrm>
            <a:off x="5257800" y="999870"/>
            <a:ext cx="6096000" cy="1669240"/>
          </a:xfrm>
          <a:prstGeom prst="rect">
            <a:avLst/>
          </a:prstGeom>
        </p:spPr>
        <p:txBody>
          <a:bodyPr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sz="1400" b="1">
                <a:latin typeface="Arial" panose="020B0604020202020204" pitchFamily="34" charset="0"/>
                <a:ea typeface="Times New Roman" panose="02020603050405020304" pitchFamily="18" charset="0"/>
              </a:rPr>
              <a:t>Suppl.Fig.2</a:t>
            </a:r>
            <a:r>
              <a:rPr lang="en-GB" sz="1400" b="1" dirty="0">
                <a:latin typeface="Arial" panose="020B0604020202020204" pitchFamily="34" charset="0"/>
                <a:ea typeface="Times New Roman" panose="02020603050405020304" pitchFamily="18" charset="0"/>
              </a:rPr>
              <a:t>:</a:t>
            </a:r>
            <a:r>
              <a:rPr lang="en-GB" sz="1400" dirty="0">
                <a:latin typeface="Arial" panose="020B0604020202020204" pitchFamily="34" charset="0"/>
                <a:ea typeface="Times New Roman" panose="02020603050405020304" pitchFamily="18" charset="0"/>
              </a:rPr>
              <a:t> C</a:t>
            </a:r>
            <a:r>
              <a:rPr lang="en-US" sz="1400" dirty="0" err="1">
                <a:latin typeface="Arial" panose="020B0604020202020204" pitchFamily="34" charset="0"/>
                <a:ea typeface="Times New Roman" panose="02020603050405020304" pitchFamily="18" charset="0"/>
              </a:rPr>
              <a:t>orrelation</a:t>
            </a:r>
            <a:r>
              <a:rPr lang="en-US" sz="1400" dirty="0">
                <a:latin typeface="Arial" panose="020B0604020202020204" pitchFamily="34" charset="0"/>
                <a:ea typeface="Times New Roman" panose="02020603050405020304" pitchFamily="18" charset="0"/>
              </a:rPr>
              <a:t> analyzes between antibody titers and corresponding IC50 values. Spearman’s rank correlation coefficient was calculated from antibody titers and IC50 values obtained from neutralization curves. Overall, we found a significant, positive and moderate relation (r=0.5084; p=0.0041) for all patients groups. </a:t>
            </a:r>
            <a:endParaRPr lang="en-US" sz="1400" dirty="0"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375617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0</Words>
  <Application>Microsoft Office PowerPoint</Application>
  <PresentationFormat>Breitbild</PresentationFormat>
  <Paragraphs>6</Paragraphs>
  <Slides>2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Prism 8</vt:lpstr>
      <vt:lpstr>PowerPoint-Präsentation</vt:lpstr>
      <vt:lpstr>PowerPoint-Präsentation</vt:lpstr>
    </vt:vector>
  </TitlesOfParts>
  <Company>MUI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fon Eliott</dc:creator>
  <cp:lastModifiedBy>Posch Wilfried</cp:lastModifiedBy>
  <cp:revision>57</cp:revision>
  <cp:lastPrinted>2021-01-14T09:35:34Z</cp:lastPrinted>
  <dcterms:created xsi:type="dcterms:W3CDTF">2020-12-17T14:14:49Z</dcterms:created>
  <dcterms:modified xsi:type="dcterms:W3CDTF">2021-06-01T09:04:45Z</dcterms:modified>
</cp:coreProperties>
</file>